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51127A5-063D-44A3-98E3-0A4A750B654A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3DF2602-8C9F-4C8A-87C3-8D77AF38AAFC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CC8E620-105E-41CC-9541-54D485777B67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E8599F7-4BA3-4614-A007-59597A9E6A07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DE92390-36E8-480E-84F8-C6AE12855B3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75E2B57-E744-4A26-B0F4-22A8CBFF8DE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E4226F3-5BEF-424D-A12D-71FF4E37E91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1F33025-BC31-45B6-B34C-20093A32618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CCFD07C-33B3-4A5C-B1BD-CAECAE8ABB7F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0ED9B57-06CA-4859-90AE-8E3479C9279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ECBB257-9C51-4A1E-9E22-D9B7977E274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30832DE-4D0D-4CE6-8239-E85B0F5BCDA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굴림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굴림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굴림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굴림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굴림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굴림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굴림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굴림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굴림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굴림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굴림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굴림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굴림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굴림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굴림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ko-KR" sz="1400" spc="-1" strike="noStrike">
                <a:solidFill>
                  <a:srgbClr val="000000"/>
                </a:solidFill>
                <a:latin typeface="굴림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ko-KR" sz="1400" spc="-1" strike="noStrike">
                <a:solidFill>
                  <a:srgbClr val="000000"/>
                </a:solidFill>
                <a:latin typeface="굴림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ko-KR" sz="1400" spc="-1" strike="noStrike">
                <a:solidFill>
                  <a:srgbClr val="000000"/>
                </a:solidFill>
                <a:latin typeface="굴림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ko-KR" sz="1400" spc="-1" strike="noStrike">
                <a:solidFill>
                  <a:srgbClr val="000000"/>
                </a:solidFill>
                <a:latin typeface="굴림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ko-KR" sz="1400" spc="-1" strike="noStrike">
                <a:solidFill>
                  <a:srgbClr val="000000"/>
                </a:solidFill>
                <a:latin typeface="굴림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26E3B3D3-4031-48BD-A299-ADC929104440}" type="slidenum">
              <a:rPr b="0" lang="ko-KR" sz="1400" spc="-1" strike="noStrike">
                <a:solidFill>
                  <a:srgbClr val="000000"/>
                </a:solidFill>
                <a:latin typeface="굴림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굴림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1" name=""/>
          <p:cNvGraphicFramePr/>
          <p:nvPr/>
        </p:nvGraphicFramePr>
        <p:xfrm>
          <a:off x="1835280" y="1569960"/>
          <a:ext cx="5329080" cy="3579840"/>
        </p:xfrm>
        <a:graphic>
          <a:graphicData uri="http://schemas.openxmlformats.org/drawingml/2006/table">
            <a:tbl>
              <a:tblPr/>
              <a:tblGrid>
                <a:gridCol w="3024000"/>
                <a:gridCol w="649440"/>
                <a:gridCol w="718920"/>
                <a:gridCol w="936720"/>
              </a:tblGrid>
              <a:tr h="279360">
                <a:tc>
                  <a:txBody>
                    <a:bodyPr lIns="36000" rIns="36000" tIns="1800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Gene name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36000" marR="36000">
                    <a:lnL>
                      <a:noFill/>
                    </a:lnL>
                    <a:lnR>
                      <a:noFill/>
                    </a:lnR>
                    <a:lnT w="93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6000" rIns="36000" tIns="1800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Symbol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36000" marR="36000">
                    <a:lnL>
                      <a:noFill/>
                    </a:lnL>
                    <a:lnR>
                      <a:noFill/>
                    </a:lnR>
                    <a:lnT w="93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6000" rIns="36000" tIns="1800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Fold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(TR/RIF-1)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36000" marR="36000">
                    <a:lnL>
                      <a:noFill/>
                    </a:lnL>
                    <a:lnR>
                      <a:noFill/>
                    </a:lnR>
                    <a:lnT w="93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6000" rIns="36000" tIns="1800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ko-KR" sz="8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Acession No.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36000" marR="36000">
                    <a:lnL>
                      <a:noFill/>
                    </a:lnL>
                    <a:lnR>
                      <a:noFill/>
                    </a:lnR>
                    <a:lnT w="93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</a:tr>
              <a:tr h="157320">
                <a:tc>
                  <a:txBody>
                    <a:bodyPr lIns="36000" rIns="36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ko-KR" sz="8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creatine kinase, brain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36000" marR="36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6000" rIns="36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ko-KR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Ckb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36000" marR="36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6000" rIns="36000" tIns="1800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8000"/>
                          </a:solidFill>
                          <a:latin typeface="Arial"/>
                          <a:ea typeface="돋움"/>
                        </a:rPr>
                        <a:t>-46.07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36000" marR="36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6000" rIns="36000" tIns="1800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NM_021273.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36000" marR="360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156960">
                <a:tc>
                  <a:txBody>
                    <a:bodyPr lIns="36000" rIns="36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ko-KR" sz="8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protein tyrosine phosphatase, non-receptor type substrate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6000" rIns="36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Ptpns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6000" rIns="36000" tIns="1800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8000"/>
                          </a:solidFill>
                          <a:latin typeface="Arial"/>
                          <a:ea typeface="돋움"/>
                        </a:rPr>
                        <a:t>-11.35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6000" rIns="36000" tIns="1800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XM_149178.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157320">
                <a:tc>
                  <a:txBody>
                    <a:bodyPr lIns="36000" rIns="36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ko-KR" sz="8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lysyl oxidase-like 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6000" rIns="36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Loxl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6000" rIns="36000" tIns="1800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8000"/>
                          </a:solidFill>
                          <a:latin typeface="Arial"/>
                          <a:ea typeface="돋움"/>
                        </a:rPr>
                        <a:t>-10.18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6000" rIns="36000" tIns="1800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NM_010729.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157320">
                <a:tc>
                  <a:txBody>
                    <a:bodyPr lIns="36000" rIns="36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ko-KR" sz="8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adenylate cyclase 8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6000" rIns="36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dcy8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6000" rIns="36000" tIns="1800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8000"/>
                          </a:solidFill>
                          <a:latin typeface="Arial"/>
                          <a:ea typeface="돋움"/>
                        </a:rPr>
                        <a:t>-8.15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6000" rIns="36000" tIns="1800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NM_009623.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156960">
                <a:tc>
                  <a:txBody>
                    <a:bodyPr lIns="36000" rIns="36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T-cell lymphoma invasion and metastasis 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6000" rIns="36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Tiam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6000" rIns="36000" tIns="1800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8000"/>
                          </a:solidFill>
                          <a:latin typeface="Arial"/>
                          <a:ea typeface="돋움"/>
                        </a:rPr>
                        <a:t>-6.82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6000" rIns="36000" tIns="1800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NM_009384.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157320">
                <a:tc>
                  <a:txBody>
                    <a:bodyPr lIns="36000" rIns="36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B-cell leukemia/lymphoma 11B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6000" rIns="36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Bcl11b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6000" rIns="36000" tIns="1800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8000"/>
                          </a:solidFill>
                          <a:latin typeface="Arial"/>
                          <a:ea typeface="돋움"/>
                        </a:rPr>
                        <a:t>-6.74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6000" rIns="36000" tIns="1800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NM_021399.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156960">
                <a:tc>
                  <a:txBody>
                    <a:bodyPr lIns="36000" rIns="36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expressed sequence AI747699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6000" rIns="36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I747699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6000" rIns="36000" tIns="1800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8000"/>
                          </a:solidFill>
                          <a:latin typeface="Arial"/>
                          <a:ea typeface="돋움"/>
                        </a:rPr>
                        <a:t>-6.73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6000" rIns="36000" tIns="1800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NM_001013770.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157320">
                <a:tc>
                  <a:txBody>
                    <a:bodyPr lIns="36000" rIns="36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ko-KR" sz="8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nestin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6000" rIns="36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ko-KR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Nes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6000" rIns="36000" tIns="1800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8000"/>
                          </a:solidFill>
                          <a:latin typeface="Arial"/>
                          <a:ea typeface="돋움"/>
                        </a:rPr>
                        <a:t>-6.12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6000" rIns="36000" tIns="1800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NM_016701.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156960">
                <a:tc>
                  <a:txBody>
                    <a:bodyPr lIns="36000" rIns="36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ko-KR" sz="8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ADP-ribosylation factor-like 6 interacting protein 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6000" rIns="36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rl6ip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6000" rIns="36000" tIns="1800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8000"/>
                          </a:solidFill>
                          <a:latin typeface="Arial"/>
                          <a:ea typeface="돋움"/>
                        </a:rPr>
                        <a:t>-5.70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6000" rIns="36000" tIns="1800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NM_019419.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157320">
                <a:tc>
                  <a:txBody>
                    <a:bodyPr lIns="36000" rIns="36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cellular retinoic acid binding protein I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6000" rIns="36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Crabp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6000" rIns="36000" tIns="1800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8000"/>
                          </a:solidFill>
                          <a:latin typeface="Arial"/>
                          <a:ea typeface="돋움"/>
                        </a:rPr>
                        <a:t>-5.26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6000" rIns="36000" tIns="1800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NM_013496.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157320">
                <a:tc>
                  <a:txBody>
                    <a:bodyPr lIns="36000" rIns="36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ko-KR" sz="8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matrix gamma-carboxyglutamate (gla) protein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6000" rIns="36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ko-KR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Mglap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6000" rIns="36000" tIns="1800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8000"/>
                          </a:solidFill>
                          <a:latin typeface="Arial"/>
                          <a:ea typeface="돋움"/>
                        </a:rPr>
                        <a:t>-5.04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6000" rIns="36000" tIns="1800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NM_008597.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156960">
                <a:tc>
                  <a:txBody>
                    <a:bodyPr lIns="36000" rIns="36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ko-KR" sz="8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secretory carrier membrane protein 5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6000" rIns="36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Scamp5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6000" rIns="36000" tIns="1800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8000"/>
                          </a:solidFill>
                          <a:latin typeface="Arial"/>
                          <a:ea typeface="돋움"/>
                        </a:rPr>
                        <a:t>-4.50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6000" rIns="36000" tIns="1800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NM_020270.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157320">
                <a:tc>
                  <a:txBody>
                    <a:bodyPr lIns="36000" rIns="36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ko-KR" sz="8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amphiregulin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6000" rIns="36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ko-KR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reg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6000" rIns="36000" tIns="1800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8000"/>
                          </a:solidFill>
                          <a:latin typeface="Arial"/>
                          <a:ea typeface="돋움"/>
                        </a:rPr>
                        <a:t>-4.00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6000" rIns="36000" tIns="1800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NM_009704.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156960">
                <a:tc>
                  <a:txBody>
                    <a:bodyPr lIns="36000" rIns="36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four and a half LIM domains 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6000" rIns="36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Fhl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6000" rIns="36000" tIns="1800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8000"/>
                          </a:solidFill>
                          <a:latin typeface="Arial"/>
                          <a:ea typeface="돋움"/>
                        </a:rPr>
                        <a:t>-4.00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6000" rIns="36000" tIns="1800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NM_010211.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157320">
                <a:tc>
                  <a:txBody>
                    <a:bodyPr lIns="36000" rIns="36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ko-KR" sz="8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Rho GDP dissociation inhibitor (GDI) gamma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6000" rIns="36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ko-KR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rhgdig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6000" rIns="36000" tIns="1800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8000"/>
                          </a:solidFill>
                          <a:latin typeface="Arial"/>
                          <a:ea typeface="돋움"/>
                        </a:rPr>
                        <a:t>-3.87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6000" rIns="36000" tIns="1800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NM_008113.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156960">
                <a:tc>
                  <a:txBody>
                    <a:bodyPr lIns="36000" rIns="36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ko-KR" sz="8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serum/glucocorticoid regulated kinase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6000" rIns="36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ko-KR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Sgk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6000" rIns="36000" tIns="1800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8000"/>
                          </a:solidFill>
                          <a:latin typeface="Arial"/>
                          <a:ea typeface="돋움"/>
                        </a:rPr>
                        <a:t>-3.78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6000" rIns="36000" tIns="1800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NM_01136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157320">
                <a:tc>
                  <a:txBody>
                    <a:bodyPr lIns="36000" rIns="36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lymphocyte antigen 6 complex, locus A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6000" rIns="36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Ly6a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6000" rIns="36000" tIns="1800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8000"/>
                          </a:solidFill>
                          <a:latin typeface="Arial"/>
                          <a:ea typeface="돋움"/>
                        </a:rPr>
                        <a:t>-3.72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6000" rIns="36000" tIns="1800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NM_010738.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156960">
                <a:tc>
                  <a:txBody>
                    <a:bodyPr lIns="36000" rIns="36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family with sequence similarity 132, member A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6000" rIns="36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Fam132a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6000" rIns="36000" tIns="1800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8000"/>
                          </a:solidFill>
                          <a:latin typeface="Arial"/>
                          <a:ea typeface="돋움"/>
                        </a:rPr>
                        <a:t>-3.56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6000" rIns="36000" tIns="1800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NM_026125.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157320">
                <a:tc>
                  <a:txBody>
                    <a:bodyPr lIns="36000" rIns="36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matrix metalloproteinase 3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6000" rIns="36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Mmp3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6000" rIns="36000" tIns="1800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8000"/>
                          </a:solidFill>
                          <a:latin typeface="Arial"/>
                          <a:ea typeface="돋움"/>
                        </a:rPr>
                        <a:t>-3.30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6000" rIns="36000" tIns="1800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NM_010809.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157320">
                <a:tc>
                  <a:txBody>
                    <a:bodyPr lIns="36000" rIns="36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scavenger receptor class A, member 3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6000" rIns="36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Scara3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6000" rIns="36000" tIns="1800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8000"/>
                          </a:solidFill>
                          <a:latin typeface="Arial"/>
                          <a:ea typeface="돋움"/>
                        </a:rPr>
                        <a:t>-3.30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6000" rIns="36000" tIns="1800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NM_172604.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156960">
                <a:tc>
                  <a:txBody>
                    <a:bodyPr lIns="36000" rIns="36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ko-KR" sz="800" spc="-1" strike="noStrike">
                          <a:solidFill>
                            <a:srgbClr val="000000"/>
                          </a:solidFill>
                          <a:latin typeface="Arial"/>
                          <a:ea typeface="돋움"/>
                        </a:rPr>
                        <a:t>whirlin (Whrn), transcript variant 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93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6000" rIns="36000" tIns="18000" bIns="1800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ko-KR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Whrn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93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6000" rIns="36000" tIns="1800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8000"/>
                          </a:solidFill>
                          <a:latin typeface="Arial"/>
                          <a:ea typeface="돋움"/>
                        </a:rPr>
                        <a:t>-3.12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93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6000" rIns="36000" tIns="18000" bIns="1800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XM_196324.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36000" marR="36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93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</a:tr>
            </a:tbl>
          </a:graphicData>
        </a:graphic>
      </p:graphicFrame>
      <p:sp>
        <p:nvSpPr>
          <p:cNvPr id="42" name="Text Box 1139"/>
          <p:cNvSpPr/>
          <p:nvPr/>
        </p:nvSpPr>
        <p:spPr>
          <a:xfrm>
            <a:off x="1692360" y="1052640"/>
            <a:ext cx="63482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Table S2. Genes down-regulated more than 3-fold in TR cells compared to RIF-1 cells.</a:t>
            </a:r>
            <a:endParaRPr b="0" lang="en-US" sz="1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43" name="Text Box 1141"/>
          <p:cNvSpPr/>
          <p:nvPr/>
        </p:nvSpPr>
        <p:spPr>
          <a:xfrm>
            <a:off x="104040" y="0"/>
            <a:ext cx="25048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굴림"/>
              </a:rPr>
              <a:t>Supplemental Table 2</a:t>
            </a:r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1-06-14T01:50:21Z</dcterms:created>
  <dc:creator>김희정</dc:creator>
  <dc:description/>
  <dc:language>en-US</dc:language>
  <cp:lastModifiedBy>김희정</cp:lastModifiedBy>
  <dcterms:modified xsi:type="dcterms:W3CDTF">2011-06-14T01:50:28Z</dcterms:modified>
  <cp:revision>1</cp:revision>
  <dc:subject/>
  <dc:title>슬라이드 1</dc:title>
</cp:coreProperties>
</file>